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102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6D9D55-3822-499E-91E2-1B53756A33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0C73BE2-3FDC-425D-A6E4-68AF1DBF7B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77CF6D3-DD25-41D8-97B8-18EE507F0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83E735-AC3F-498D-AA60-DFA1EEF73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E83927-97FD-429E-AA5D-CA75D59DC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6126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85F65A-35BD-4EB7-BC51-F8116898CE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BA33338-09D9-490F-9337-1D120A6E35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F0BA7CF-4B29-45BA-A72C-A294E83D4A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01C7A0-5232-448C-9577-7D422CC5D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0081AA8-3BC2-4274-B39D-BF4EAC7D6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417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42C7145-7336-4310-971F-2E3E5FECD8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AFA4C70-2336-44C2-87F8-3DCCA6AC24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7CC4A39-ACCC-48FF-8789-8297E4212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FB052D8-2C14-44C1-A429-F166B4E8D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CF6DFC-EF0E-4F51-8BB4-C57A6A01D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7633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FDEF61-81F6-4334-92EC-174ACB4FB0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9D8629-263E-4F18-89C1-5373C42AB5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3C2FA2-69CC-4C38-A7E2-C988111FB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61BA53-B403-43E6-B8FF-04C6BBA2C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57FA18-63F6-4136-9D9A-60ADDBDFB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039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6376F4-ECBA-4409-82BE-A895919DFF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7A14418-8BC8-4D66-8EC1-F0BD83260B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1C3F28D-206E-474F-8B8F-1A3BE831F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BDC622-1736-439E-9D4A-DBB07FFDA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87EB2D-1943-4E00-81DC-4E0299D37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8566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DB247B-387D-4B54-9E76-42EC91A785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5608CB7-7F38-4F3E-92D7-12F89F7581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020C7B9-3465-4484-8379-A6EBA80B6E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5DF4EAD-0B1F-41F0-BB9B-B0909B13E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160B425-8E6B-4166-A2D7-C01B223D4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6B7EC1C-BAD9-480B-A377-F14261087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1644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7DC408-4470-4E7E-9183-5EA7E22711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AD2B8F-36F7-448C-91C2-F781F7B2C3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92C8457-0B55-41A9-859F-E9FFF49268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720ED9E-BC34-49D4-90BE-DEDBACF32A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EB9610F-6EA1-4A51-BD66-CD6F96B3EE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1CE9806-D5DC-48F3-8025-CB87B7600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C901854-7B8F-45FE-A703-C68EA4833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3082F02-EA78-44E1-AF70-4C9BD0D09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7468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51E056-6277-4534-A4EF-1B327967CF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5F0685A-7EC7-48A9-8EF6-344B14513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BA2A5A9-299D-4C3B-AE4F-884470851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D60864A-0819-45B5-A1C5-A1987A90D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5745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DE742BC-B42E-4EAE-93B9-1CEB7D938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670BCDE-7C41-40F3-A102-E483525B2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994D12C-5FA8-44FE-BEBA-E8E5A85E1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8560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DCD747-1802-4B34-AD11-04C2506FB0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52CBBFE-C0CD-47CB-9D92-C3EF5F39B6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9034397-4DEE-4049-A404-B81DB427B2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9980631-0611-4D40-A551-6AA17F149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E89AB4F-D811-48EC-BAE3-E82C988F2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E99BA30-38B5-4A1D-82BA-8AFBED7DC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8004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8767E3-9F62-4860-9939-B835A8553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144921C-6B2A-401B-919B-5E2EE1B86A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6024BD5-BEE2-4F24-A29F-DC70036FF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E835215-34AA-4823-B7AD-E0B0B1CCE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C2EE005-E8FA-4082-BE53-914F004C6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AFD5558-1BC8-4DFE-A92D-B405F3003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8526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BC72A2E-233B-49E7-9B4A-7D4E9A64C7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5A8783-C9B6-4262-9051-85A6729224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638CB4-46BB-4DBD-8372-0AE0E0DEFE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E29B69-DA9B-4FE3-A182-6560A711399C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5C89D2-7133-44E2-8FC8-AFB4E8142E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573F4C-B8DC-4C91-AE05-F4D6F3EF13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3C726-C8BF-4559-A2AE-3E2029A72C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374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E197C81-9386-4263-AC21-A6A45244F5A4}"/>
              </a:ext>
            </a:extLst>
          </p:cNvPr>
          <p:cNvSpPr txBox="1"/>
          <p:nvPr/>
        </p:nvSpPr>
        <p:spPr>
          <a:xfrm>
            <a:off x="-1748118" y="-19831"/>
            <a:ext cx="8525435" cy="5693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able</a:t>
            </a:r>
            <a:r>
              <a:rPr lang="en-US" altLang="ja-JP" sz="100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1.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haracteristics of patients undergoing PD for distal cholangiocarcinoma</a:t>
            </a:r>
            <a:endParaRPr lang="ja-JP" altLang="ja-JP" sz="1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00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64057F1-9692-4A7E-85B0-D67121D8D67B}"/>
              </a:ext>
            </a:extLst>
          </p:cNvPr>
          <p:cNvSpPr txBox="1"/>
          <p:nvPr/>
        </p:nvSpPr>
        <p:spPr>
          <a:xfrm>
            <a:off x="502023" y="6202299"/>
            <a:ext cx="11478185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Hb: hemoglobin; Alb: albumin; TP: total protein; PA: prealbumin; T CHO: total cholesterol; </a:t>
            </a:r>
            <a:r>
              <a:rPr lang="en-US" altLang="ja-JP" sz="1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GPS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odified Glasgow Prognostic Score; NLR: neutrophil-to-lymphocyte ratio; PLR: platelet-to-lymphocyte ratio; PNI: prognostic nutritional index; BMI: body mass index; PMI: psoas muscle mass index; CA19-9: carbohydrate antigen 19-9; CRP: C-reactive protein; RFS: recurrence free survival; IQR: interquartile range</a:t>
            </a:r>
            <a:endParaRPr lang="ja-JP" altLang="ja-JP" sz="1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93EB1D17-DDF9-4D72-B64E-131BA9A7B1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4593360"/>
              </p:ext>
            </p:extLst>
          </p:nvPr>
        </p:nvGraphicFramePr>
        <p:xfrm>
          <a:off x="3767231" y="666859"/>
          <a:ext cx="4298950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Worksheet" r:id="rId3" imgW="8039256" imgH="10134378" progId="Excel.Sheet.12">
                  <p:embed/>
                </p:oleObj>
              </mc:Choice>
              <mc:Fallback>
                <p:oleObj name="Worksheet" r:id="rId3" imgW="8039256" imgH="1013437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67231" y="666859"/>
                        <a:ext cx="4298950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283384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Microsoft Excel ワークシー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梅澤 早織</dc:creator>
  <cp:lastModifiedBy>梅澤 早織</cp:lastModifiedBy>
  <cp:revision>2</cp:revision>
  <dcterms:created xsi:type="dcterms:W3CDTF">2022-03-27T03:23:05Z</dcterms:created>
  <dcterms:modified xsi:type="dcterms:W3CDTF">2022-03-27T03:45:52Z</dcterms:modified>
</cp:coreProperties>
</file>